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09" r:id="rId2"/>
    <p:sldId id="310" r:id="rId3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21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/>
    <p:restoredTop sz="92017"/>
  </p:normalViewPr>
  <p:slideViewPr>
    <p:cSldViewPr snapToGrid="0">
      <p:cViewPr>
        <p:scale>
          <a:sx n="240" d="100"/>
          <a:sy n="240" d="100"/>
        </p:scale>
        <p:origin x="-344" y="144"/>
      </p:cViewPr>
      <p:guideLst>
        <p:guide orient="horz" pos="2621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9F04B6-F912-E44D-B4F8-91F0A27773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387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emf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>
            <a:extLst>
              <a:ext uri="{FF2B5EF4-FFF2-40B4-BE49-F238E27FC236}">
                <a16:creationId xmlns:a16="http://schemas.microsoft.com/office/drawing/2014/main" id="{DDBD43C6-1901-FD2E-323E-D6626B14B4D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8336"/>
          <a:stretch/>
        </p:blipFill>
        <p:spPr>
          <a:xfrm>
            <a:off x="398529" y="7957967"/>
            <a:ext cx="1857132" cy="1833285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40EB0596-61B5-3E9B-1E29-653A973F5F2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1896" b="51808"/>
          <a:stretch/>
        </p:blipFill>
        <p:spPr>
          <a:xfrm>
            <a:off x="498559" y="4580261"/>
            <a:ext cx="1757102" cy="3253871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5F7FD8BB-4AF9-D601-114C-AF71FFEE5926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b="19268"/>
          <a:stretch/>
        </p:blipFill>
        <p:spPr>
          <a:xfrm>
            <a:off x="184323" y="249876"/>
            <a:ext cx="5517392" cy="2041561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54FFF3FF-65CF-FAE6-4AF4-7CABF75FB11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84846" r="53328"/>
          <a:stretch/>
        </p:blipFill>
        <p:spPr>
          <a:xfrm>
            <a:off x="1876441" y="2249548"/>
            <a:ext cx="2681773" cy="399104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3F9D1953-E384-1CF1-50B7-3B22B4040CAD}"/>
              </a:ext>
            </a:extLst>
          </p:cNvPr>
          <p:cNvSpPr txBox="1"/>
          <p:nvPr/>
        </p:nvSpPr>
        <p:spPr>
          <a:xfrm>
            <a:off x="167621" y="21296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2E1D144-A925-5BB7-2C75-15BE7AE53708}"/>
              </a:ext>
            </a:extLst>
          </p:cNvPr>
          <p:cNvSpPr txBox="1"/>
          <p:nvPr/>
        </p:nvSpPr>
        <p:spPr>
          <a:xfrm>
            <a:off x="168892" y="491106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B4AD867-C21D-1482-E175-65621D5A8478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B694ACB-2E89-DA9A-B889-B56972FA0630}"/>
              </a:ext>
            </a:extLst>
          </p:cNvPr>
          <p:cNvSpPr txBox="1"/>
          <p:nvPr/>
        </p:nvSpPr>
        <p:spPr>
          <a:xfrm>
            <a:off x="167621" y="23655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188C824-6092-F495-B2C3-4D990318D2DC}"/>
              </a:ext>
            </a:extLst>
          </p:cNvPr>
          <p:cNvSpPr txBox="1"/>
          <p:nvPr/>
        </p:nvSpPr>
        <p:spPr>
          <a:xfrm>
            <a:off x="167621" y="80221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DBAEFE49-876A-BC76-F2E2-3DE973FE0D6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2664855"/>
            <a:ext cx="6858000" cy="19050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2073F434-B932-6B22-D317-AA0F473B142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23722" t="1896" b="86417"/>
          <a:stretch/>
        </p:blipFill>
        <p:spPr>
          <a:xfrm>
            <a:off x="2537226" y="4569855"/>
            <a:ext cx="1340276" cy="821399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677FFD8B-0083-D5E4-211C-4C8930257AAF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t="48232" r="21270" b="23146"/>
          <a:stretch/>
        </p:blipFill>
        <p:spPr>
          <a:xfrm>
            <a:off x="2134832" y="5391913"/>
            <a:ext cx="1383376" cy="2011568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588C1610-9757-52BD-CD6B-ADA778123EB9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t="76822" b="-348"/>
          <a:stretch/>
        </p:blipFill>
        <p:spPr>
          <a:xfrm>
            <a:off x="3777112" y="5396101"/>
            <a:ext cx="1757102" cy="1653492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0F6602E1-63C4-0E9F-9E44-BA27849200B3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23722" t="1896" b="86417"/>
          <a:stretch/>
        </p:blipFill>
        <p:spPr>
          <a:xfrm>
            <a:off x="4183589" y="4567268"/>
            <a:ext cx="1340276" cy="821399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1801B866-CDF2-E9D5-5DC6-8823AFB2FE6F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77095" t="50526" r="-38866" b="37704"/>
          <a:stretch/>
        </p:blipFill>
        <p:spPr>
          <a:xfrm>
            <a:off x="5337438" y="5841220"/>
            <a:ext cx="1085385" cy="827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20816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213A85F-873E-3C90-290C-1A62490DAA57}"/>
              </a:ext>
            </a:extLst>
          </p:cNvPr>
          <p:cNvSpPr txBox="1"/>
          <p:nvPr/>
        </p:nvSpPr>
        <p:spPr>
          <a:xfrm>
            <a:off x="413951" y="278027"/>
            <a:ext cx="601774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5. Addition of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to CRT does not enhance the immunogenicity of the MOC1 model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Volcano plots showing differential expression of genes across the different treatment conditions.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B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 Volcano plots for gene set enrichment analysis results (Gene Ontology Biological Processes terms) across different treatment conditions (NES, Normalized enrichment score). Pathways denoted in red represent terms with adjusted p-values &lt; 0.05 (corrected for multiple testing). Labels indicate the top five significantly up- and down-regulated terms, as well as five immune-related processes of interest: type I/II interferon production, activation of immune response, positive regulation of adaptive/innate immune response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Heatmaps corresponding to IAP, interferon and cytokine signalling, co-stimulatory and chemoattractant pathways, activation status, immune checkpoint markers, HLAs and immune cell populations across different treatment conditions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Tumour microenvironment cell type signature scores across different treatment conditions shown as Z-scores of mean GSVA signature scores per condition (5 tumours/group).</a:t>
            </a:r>
          </a:p>
        </p:txBody>
      </p:sp>
    </p:spTree>
    <p:extLst>
      <p:ext uri="{BB962C8B-B14F-4D97-AF65-F5344CB8AC3E}">
        <p14:creationId xmlns:p14="http://schemas.microsoft.com/office/powerpoint/2010/main" val="352173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3</TotalTime>
  <Words>188</Words>
  <Application>Microsoft Macintosh PowerPoint</Application>
  <PresentationFormat>A4 Paper (210x297 mm)</PresentationFormat>
  <Paragraphs>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536</cp:revision>
  <cp:lastPrinted>2025-06-25T15:47:08Z</cp:lastPrinted>
  <dcterms:created xsi:type="dcterms:W3CDTF">2019-11-04T10:33:30Z</dcterms:created>
  <dcterms:modified xsi:type="dcterms:W3CDTF">2025-10-09T08:55:33Z</dcterms:modified>
</cp:coreProperties>
</file>